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7001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8734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05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609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79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635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2585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822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00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168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5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D73AD-AC4E-4953-BA1F-8A114012E0F2}" type="datetimeFigureOut">
              <a:rPr lang="en-GB" smtClean="0"/>
              <a:t>07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E0EC9-E5FF-4ACE-966C-1800867C31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821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2DFCF298-FF8A-490A-915B-A78B94D3F74A}"/>
              </a:ext>
            </a:extLst>
          </p:cNvPr>
          <p:cNvSpPr txBox="1"/>
          <p:nvPr/>
        </p:nvSpPr>
        <p:spPr>
          <a:xfrm>
            <a:off x="1277959" y="10338620"/>
            <a:ext cx="41273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Untreated and OA+EO treated intestinal organoids grown in floating organoid medium (FOM). Organoids were treated for 48 h with a low (0.25 mg/mL) or high (0.5 mg/mL) of OA+EO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0BED44D-96E4-47DD-AA9E-27CCB22FF819}"/>
              </a:ext>
            </a:extLst>
          </p:cNvPr>
          <p:cNvGrpSpPr/>
          <p:nvPr/>
        </p:nvGrpSpPr>
        <p:grpSpPr>
          <a:xfrm>
            <a:off x="1219448" y="884525"/>
            <a:ext cx="4185836" cy="9039531"/>
            <a:chOff x="452532" y="300809"/>
            <a:chExt cx="4185836" cy="903953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8F7F7F5-839A-42BF-9D55-5EE40437B097}"/>
                </a:ext>
              </a:extLst>
            </p:cNvPr>
            <p:cNvGrpSpPr/>
            <p:nvPr/>
          </p:nvGrpSpPr>
          <p:grpSpPr>
            <a:xfrm>
              <a:off x="452532" y="300809"/>
              <a:ext cx="4185836" cy="9039531"/>
              <a:chOff x="452532" y="300809"/>
              <a:chExt cx="4185836" cy="9039531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4C6C09E-E305-4DE9-B18A-276ED72381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0430" b="42581"/>
              <a:stretch/>
            </p:blipFill>
            <p:spPr>
              <a:xfrm>
                <a:off x="553065" y="300809"/>
                <a:ext cx="4085303" cy="2953365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D4F37D0B-3DBE-4B53-BD07-7F822D1399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53064" y="3343892"/>
                <a:ext cx="4085304" cy="2953365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A709C68-E1AD-46F2-9972-02FF0BEF7397}"/>
                  </a:ext>
                </a:extLst>
              </p:cNvPr>
              <p:cNvSpPr txBox="1"/>
              <p:nvPr/>
            </p:nvSpPr>
            <p:spPr>
              <a:xfrm>
                <a:off x="452532" y="6001665"/>
                <a:ext cx="184512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0" i="0" u="none" strike="noStrike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0.25 mg/mL OA+EO 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08CD1D8-4E78-44CF-AB4E-C722A25506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53063" y="6386975"/>
                <a:ext cx="4085305" cy="2953365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5CC7B25-B7E7-40F0-95BA-0457CAA54416}"/>
                  </a:ext>
                </a:extLst>
              </p:cNvPr>
              <p:cNvSpPr txBox="1"/>
              <p:nvPr/>
            </p:nvSpPr>
            <p:spPr>
              <a:xfrm>
                <a:off x="511042" y="9030000"/>
                <a:ext cx="174573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GB" sz="1400" b="0" i="0" u="none" strike="noStrike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0.5 mg/mL OA+EO 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4B5FB4D-DC2C-418C-9432-90FAE7C95BE4}"/>
                </a:ext>
              </a:extLst>
            </p:cNvPr>
            <p:cNvSpPr txBox="1"/>
            <p:nvPr/>
          </p:nvSpPr>
          <p:spPr>
            <a:xfrm>
              <a:off x="553063" y="2958582"/>
              <a:ext cx="164634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1400" b="0" i="0" u="none" strike="noStrike" baseline="0" dirty="0">
                  <a:latin typeface="Arial" panose="020B0604020202020204" pitchFamily="34" charset="0"/>
                  <a:cs typeface="Arial" panose="020B0604020202020204" pitchFamily="34" charset="0"/>
                </a:rPr>
                <a:t>0 mg/mL OA+EO 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40376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6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nneke Vervelde</dc:creator>
  <cp:lastModifiedBy>Lonneke Vervelde</cp:lastModifiedBy>
  <cp:revision>8</cp:revision>
  <dcterms:created xsi:type="dcterms:W3CDTF">2024-02-05T08:16:44Z</dcterms:created>
  <dcterms:modified xsi:type="dcterms:W3CDTF">2024-04-07T14:16:30Z</dcterms:modified>
</cp:coreProperties>
</file>